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9144000" cy="6858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39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4721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57348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66039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74407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62340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97573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33168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11497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42780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83009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92623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B6C70-329D-41AE-829F-C200A24CA356}" type="datetimeFigureOut">
              <a:rPr lang="es-MX" smtClean="0"/>
              <a:t>15/09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B5831-C973-4C1D-943B-4146D4A3AE7F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3604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5 Grupo"/>
          <p:cNvGrpSpPr/>
          <p:nvPr/>
        </p:nvGrpSpPr>
        <p:grpSpPr>
          <a:xfrm>
            <a:off x="35496" y="116632"/>
            <a:ext cx="9001000" cy="6453717"/>
            <a:chOff x="35496" y="116632"/>
            <a:chExt cx="9001000" cy="6453717"/>
          </a:xfrm>
        </p:grpSpPr>
        <p:grpSp>
          <p:nvGrpSpPr>
            <p:cNvPr id="2" name="1 Grupo"/>
            <p:cNvGrpSpPr/>
            <p:nvPr/>
          </p:nvGrpSpPr>
          <p:grpSpPr>
            <a:xfrm>
              <a:off x="35496" y="116632"/>
              <a:ext cx="9001000" cy="5904336"/>
              <a:chOff x="35496" y="260648"/>
              <a:chExt cx="9001000" cy="5760320"/>
            </a:xfrm>
          </p:grpSpPr>
          <p:pic>
            <p:nvPicPr>
              <p:cNvPr id="18" name="Picture 5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36496" y="260648"/>
                <a:ext cx="4500000" cy="288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3" name="Picture 5" descr="C:\Users\cvilla\Pictures\DSC_0315.JP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496" y="260648"/>
                <a:ext cx="4500000" cy="2880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6" name="Picture 8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496" y="3140968"/>
                <a:ext cx="4500000" cy="288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9" name="Picture 11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99992" y="3140968"/>
                <a:ext cx="4536504" cy="288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5" name="4 CuadroTexto"/>
            <p:cNvSpPr txBox="1"/>
            <p:nvPr/>
          </p:nvSpPr>
          <p:spPr>
            <a:xfrm>
              <a:off x="222143" y="6231795"/>
              <a:ext cx="48846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. Rain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uddles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B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round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pool, 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nd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 D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itch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 </a:t>
              </a:r>
              <a:endParaRPr lang="es-MX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2 CuadroTexto"/>
            <p:cNvSpPr txBox="1"/>
            <p:nvPr/>
          </p:nvSpPr>
          <p:spPr>
            <a:xfrm>
              <a:off x="430958" y="47106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A</a:t>
              </a:r>
              <a:endParaRPr lang="es-MX" dirty="0">
                <a:solidFill>
                  <a:schemeClr val="bg1"/>
                </a:solidFill>
              </a:endParaRPr>
            </a:p>
          </p:txBody>
        </p:sp>
        <p:sp>
          <p:nvSpPr>
            <p:cNvPr id="4" name="3 CuadroTexto"/>
            <p:cNvSpPr txBox="1"/>
            <p:nvPr/>
          </p:nvSpPr>
          <p:spPr>
            <a:xfrm>
              <a:off x="430958" y="3284984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B</a:t>
              </a:r>
              <a:endParaRPr lang="es-MX" dirty="0">
                <a:solidFill>
                  <a:schemeClr val="bg1"/>
                </a:solidFill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4843928" y="66133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C</a:t>
              </a:r>
              <a:endParaRPr lang="es-MX" dirty="0">
                <a:solidFill>
                  <a:schemeClr val="bg1"/>
                </a:solidFill>
              </a:endParaRPr>
            </a:p>
          </p:txBody>
        </p:sp>
        <p:sp>
          <p:nvSpPr>
            <p:cNvPr id="24" name="23 CuadroTexto"/>
            <p:cNvSpPr txBox="1"/>
            <p:nvPr/>
          </p:nvSpPr>
          <p:spPr>
            <a:xfrm>
              <a:off x="4779017" y="3284984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D</a:t>
              </a:r>
              <a:endParaRPr lang="es-MX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3349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6 Grupo"/>
          <p:cNvGrpSpPr/>
          <p:nvPr/>
        </p:nvGrpSpPr>
        <p:grpSpPr>
          <a:xfrm>
            <a:off x="72000" y="116632"/>
            <a:ext cx="9000000" cy="6425535"/>
            <a:chOff x="72000" y="116632"/>
            <a:chExt cx="9000000" cy="6425535"/>
          </a:xfrm>
        </p:grpSpPr>
        <p:pic>
          <p:nvPicPr>
            <p:cNvPr id="3080" name="Picture 8" descr="C:\Users\cvilla\Pictures\IMG_1734.JPG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000" y="2996952"/>
              <a:ext cx="4500000" cy="28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4" name="Picture 2" descr="C:\Users\cvilla\Pictures\DSC02238.JPG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72000" y="116632"/>
              <a:ext cx="4500000" cy="28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22" name="Picture 2" descr="C:\Users\cvilla\Pictures\DSC_0473.JPG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0" y="116632"/>
              <a:ext cx="4500000" cy="288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9" name="Picture 7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0" y="2996952"/>
              <a:ext cx="4500000" cy="28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1 CuadroTexto"/>
            <p:cNvSpPr txBox="1"/>
            <p:nvPr/>
          </p:nvSpPr>
          <p:spPr>
            <a:xfrm>
              <a:off x="251957" y="6203613"/>
              <a:ext cx="6766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tream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F </a:t>
              </a:r>
              <a:r>
                <a:rPr lang="es-MX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River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rgin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G </a:t>
              </a:r>
              <a:r>
                <a:rPr lang="es-MX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River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ol (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egative</a:t>
              </a:r>
              <a:r>
                <a:rPr lang="es-MX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, 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H </a:t>
              </a:r>
              <a:r>
                <a:rPr lang="es-MX" sz="1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goon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MX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Negative</a:t>
              </a:r>
              <a:r>
                <a:rPr lang="es-MX" sz="1600" dirty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</a:p>
          </p:txBody>
        </p:sp>
        <p:sp>
          <p:nvSpPr>
            <p:cNvPr id="3" name="2 CuadroTexto"/>
            <p:cNvSpPr txBox="1"/>
            <p:nvPr/>
          </p:nvSpPr>
          <p:spPr>
            <a:xfrm>
              <a:off x="107504" y="251356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E</a:t>
              </a:r>
              <a:endParaRPr lang="es-MX" dirty="0">
                <a:solidFill>
                  <a:schemeClr val="bg1"/>
                </a:solidFill>
              </a:endParaRPr>
            </a:p>
          </p:txBody>
        </p:sp>
        <p:sp>
          <p:nvSpPr>
            <p:cNvPr id="5" name="4 CuadroTexto"/>
            <p:cNvSpPr txBox="1"/>
            <p:nvPr/>
          </p:nvSpPr>
          <p:spPr>
            <a:xfrm>
              <a:off x="413331" y="3329315"/>
              <a:ext cx="279125" cy="3647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rgbClr val="FFFFFF"/>
                  </a:solidFill>
                </a:rPr>
                <a:t>F</a:t>
              </a:r>
              <a:endParaRPr lang="es-MX" dirty="0">
                <a:solidFill>
                  <a:srgbClr val="FFFFFF"/>
                </a:solidFill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5160588" y="354592"/>
              <a:ext cx="335651" cy="3783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G</a:t>
              </a:r>
              <a:endParaRPr lang="es-MX" dirty="0">
                <a:solidFill>
                  <a:schemeClr val="bg1"/>
                </a:solidFill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4939082" y="3144649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dirty="0" smtClean="0">
                  <a:solidFill>
                    <a:schemeClr val="bg1"/>
                  </a:solidFill>
                </a:rPr>
                <a:t>H</a:t>
              </a:r>
              <a:endParaRPr lang="es-MX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23847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41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auhtemoc Villarreal Treviño</dc:creator>
  <cp:lastModifiedBy>Americo David Rodriguez Ramirez</cp:lastModifiedBy>
  <cp:revision>25</cp:revision>
  <dcterms:created xsi:type="dcterms:W3CDTF">2014-09-03T16:22:10Z</dcterms:created>
  <dcterms:modified xsi:type="dcterms:W3CDTF">2015-09-15T19:07:31Z</dcterms:modified>
</cp:coreProperties>
</file>